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4" d="100"/>
          <a:sy n="84" d="100"/>
        </p:scale>
        <p:origin x="1382" y="11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875C7-0F7D-4A91-8210-05EDDC264854}" type="datetimeFigureOut">
              <a:rPr lang="en-CA" smtClean="0"/>
              <a:t>2023-05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FCA52-DB8D-423E-8D1D-61511E2E6B3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82113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875C7-0F7D-4A91-8210-05EDDC264854}" type="datetimeFigureOut">
              <a:rPr lang="en-CA" smtClean="0"/>
              <a:t>2023-05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FCA52-DB8D-423E-8D1D-61511E2E6B3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55299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875C7-0F7D-4A91-8210-05EDDC264854}" type="datetimeFigureOut">
              <a:rPr lang="en-CA" smtClean="0"/>
              <a:t>2023-05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FCA52-DB8D-423E-8D1D-61511E2E6B3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08042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875C7-0F7D-4A91-8210-05EDDC264854}" type="datetimeFigureOut">
              <a:rPr lang="en-CA" smtClean="0"/>
              <a:t>2023-05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FCA52-DB8D-423E-8D1D-61511E2E6B3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74870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875C7-0F7D-4A91-8210-05EDDC264854}" type="datetimeFigureOut">
              <a:rPr lang="en-CA" smtClean="0"/>
              <a:t>2023-05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FCA52-DB8D-423E-8D1D-61511E2E6B3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78678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875C7-0F7D-4A91-8210-05EDDC264854}" type="datetimeFigureOut">
              <a:rPr lang="en-CA" smtClean="0"/>
              <a:t>2023-05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FCA52-DB8D-423E-8D1D-61511E2E6B3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19226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875C7-0F7D-4A91-8210-05EDDC264854}" type="datetimeFigureOut">
              <a:rPr lang="en-CA" smtClean="0"/>
              <a:t>2023-05-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FCA52-DB8D-423E-8D1D-61511E2E6B3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95334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875C7-0F7D-4A91-8210-05EDDC264854}" type="datetimeFigureOut">
              <a:rPr lang="en-CA" smtClean="0"/>
              <a:t>2023-05-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FCA52-DB8D-423E-8D1D-61511E2E6B3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58678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875C7-0F7D-4A91-8210-05EDDC264854}" type="datetimeFigureOut">
              <a:rPr lang="en-CA" smtClean="0"/>
              <a:t>2023-05-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FCA52-DB8D-423E-8D1D-61511E2E6B3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46841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875C7-0F7D-4A91-8210-05EDDC264854}" type="datetimeFigureOut">
              <a:rPr lang="en-CA" smtClean="0"/>
              <a:t>2023-05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FCA52-DB8D-423E-8D1D-61511E2E6B3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389640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875C7-0F7D-4A91-8210-05EDDC264854}" type="datetimeFigureOut">
              <a:rPr lang="en-CA" smtClean="0"/>
              <a:t>2023-05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FCA52-DB8D-423E-8D1D-61511E2E6B3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66042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B875C7-0F7D-4A91-8210-05EDDC264854}" type="datetimeFigureOut">
              <a:rPr lang="en-CA" smtClean="0"/>
              <a:t>2023-05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BFCA52-DB8D-423E-8D1D-61511E2E6B3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97483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27499" y="2326433"/>
            <a:ext cx="5289001" cy="2205134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764177" y="336178"/>
            <a:ext cx="761564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Additional Figure 2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. A principal component analysis (PCA)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[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</a:rPr>
              <a:t>77]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performed in </a:t>
            </a:r>
            <a:r>
              <a:rPr lang="en-US" sz="1200">
                <a:latin typeface="Times New Roman" panose="02020603050405020304" pitchFamily="18" charset="0"/>
                <a:ea typeface="Arial Unicode MS" panose="020B0604020202020204" pitchFamily="34" charset="-128"/>
              </a:rPr>
              <a:t>PLINK </a:t>
            </a:r>
            <a:r>
              <a:rPr lang="en-US" sz="1200">
                <a:latin typeface="Times New Roman" panose="02020603050405020304" pitchFamily="18" charset="0"/>
                <a:ea typeface="Arial Unicode MS" panose="020B0604020202020204" pitchFamily="34" charset="-128"/>
              </a:rPr>
              <a:t>[</a:t>
            </a:r>
            <a:r>
              <a:rPr lang="en-US" sz="1200" smtClean="0">
                <a:latin typeface="Times New Roman" panose="02020603050405020304" pitchFamily="18" charset="0"/>
                <a:ea typeface="Arial Unicode MS" panose="020B0604020202020204" pitchFamily="34" charset="-128"/>
              </a:rPr>
              <a:t>78]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shows the positions of the individuals in the three subpopulations; PCA1=52.7%; PCA2=30.6%; PCA3=16.5%.</a:t>
            </a:r>
            <a:endParaRPr lang="en-CA" sz="1200" dirty="0"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0189306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3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 Unicode MS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tra Serajazari</dc:creator>
  <cp:lastModifiedBy>Mitra Serajazari</cp:lastModifiedBy>
  <cp:revision>3</cp:revision>
  <dcterms:created xsi:type="dcterms:W3CDTF">2022-06-29T17:44:50Z</dcterms:created>
  <dcterms:modified xsi:type="dcterms:W3CDTF">2023-05-15T13:22:11Z</dcterms:modified>
</cp:coreProperties>
</file>